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2252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2991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3596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1142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944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94130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6722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1539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452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0515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9764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0310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516E68-8ACB-4C59-8DC0-7C21A612C87E}" type="datetimeFigureOut">
              <a:rPr kumimoji="1" lang="ja-JP" altLang="en-US" smtClean="0"/>
              <a:t>2024/6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B924C3-5A13-415C-8D7B-51B3A27ACB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5984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p4"/><Relationship Id="rId7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9B351FF-3BB8-0669-DE18-0F2E8205F16B}"/>
              </a:ext>
            </a:extLst>
          </p:cNvPr>
          <p:cNvSpPr txBox="1"/>
          <p:nvPr/>
        </p:nvSpPr>
        <p:spPr>
          <a:xfrm>
            <a:off x="0" y="0"/>
            <a:ext cx="191770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Supplementary Video 1</a:t>
            </a:r>
            <a:endParaRPr kumimoji="1" lang="ja-JP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11FA5E9-87D8-FE1C-CC5E-E480E121E85E}"/>
              </a:ext>
            </a:extLst>
          </p:cNvPr>
          <p:cNvSpPr txBox="1"/>
          <p:nvPr/>
        </p:nvSpPr>
        <p:spPr>
          <a:xfrm>
            <a:off x="5353293" y="0"/>
            <a:ext cx="1504707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00" dirty="0">
                <a:latin typeface="Arial" panose="020B0604020202020204" pitchFamily="34" charset="0"/>
                <a:cs typeface="Arial" panose="020B0604020202020204" pitchFamily="34" charset="0"/>
              </a:rPr>
              <a:t>Teshigahara, et al</a:t>
            </a:r>
            <a:endParaRPr kumimoji="1" lang="ja-JP" alt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Supplementary Video 1A(2)">
            <a:hlinkClick r:id="" action="ppaction://media"/>
            <a:extLst>
              <a:ext uri="{FF2B5EF4-FFF2-40B4-BE49-F238E27FC236}">
                <a16:creationId xmlns:a16="http://schemas.microsoft.com/office/drawing/2014/main" id="{325BF7D5-7E88-F4E5-5945-6D898659D82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1724274" y="1385904"/>
            <a:ext cx="3569256" cy="20077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B1FF443-5E24-BE7B-3898-5B74F9C26CFD}"/>
              </a:ext>
            </a:extLst>
          </p:cNvPr>
          <p:cNvSpPr txBox="1"/>
          <p:nvPr/>
        </p:nvSpPr>
        <p:spPr>
          <a:xfrm rot="16200000">
            <a:off x="1204420" y="2251258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 week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DFAC35F-5F79-0196-20E9-8E770EDB6665}"/>
              </a:ext>
            </a:extLst>
          </p:cNvPr>
          <p:cNvSpPr txBox="1"/>
          <p:nvPr/>
        </p:nvSpPr>
        <p:spPr>
          <a:xfrm>
            <a:off x="1215154" y="108689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Supplementary Video 1B(2)">
            <a:hlinkClick r:id="" action="ppaction://media"/>
            <a:extLst>
              <a:ext uri="{FF2B5EF4-FFF2-40B4-BE49-F238E27FC236}">
                <a16:creationId xmlns:a16="http://schemas.microsoft.com/office/drawing/2014/main" id="{866CD622-52C3-C492-6090-148FBAA22E50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1724274" y="3765484"/>
            <a:ext cx="3569256" cy="20077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6E2F34F-8207-013A-FBB3-0448B43DA6A9}"/>
              </a:ext>
            </a:extLst>
          </p:cNvPr>
          <p:cNvSpPr txBox="1"/>
          <p:nvPr/>
        </p:nvSpPr>
        <p:spPr>
          <a:xfrm rot="16200000">
            <a:off x="1204420" y="4630838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4 week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C0B12A7-F975-2501-EEFD-80220CB8BDD6}"/>
              </a:ext>
            </a:extLst>
          </p:cNvPr>
          <p:cNvSpPr txBox="1"/>
          <p:nvPr/>
        </p:nvSpPr>
        <p:spPr>
          <a:xfrm>
            <a:off x="1215154" y="350855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Supplementary Video 1C(1)">
            <a:hlinkClick r:id="" action="ppaction://media"/>
            <a:extLst>
              <a:ext uri="{FF2B5EF4-FFF2-40B4-BE49-F238E27FC236}">
                <a16:creationId xmlns:a16="http://schemas.microsoft.com/office/drawing/2014/main" id="{F16085FF-A056-A92F-63EC-D32C52466467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1724274" y="6102985"/>
            <a:ext cx="3569256" cy="20077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385EE8F-A286-1404-1468-7E5467FBB7A3}"/>
              </a:ext>
            </a:extLst>
          </p:cNvPr>
          <p:cNvSpPr txBox="1"/>
          <p:nvPr/>
        </p:nvSpPr>
        <p:spPr>
          <a:xfrm rot="16200000">
            <a:off x="1161940" y="6968338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0 week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F6277A4-F83F-8A91-11EB-E2584DA4E6E4}"/>
              </a:ext>
            </a:extLst>
          </p:cNvPr>
          <p:cNvSpPr txBox="1"/>
          <p:nvPr/>
        </p:nvSpPr>
        <p:spPr>
          <a:xfrm>
            <a:off x="1215154" y="588813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44D1F42-D283-C064-C35F-FC044AE694F1}"/>
              </a:ext>
            </a:extLst>
          </p:cNvPr>
          <p:cNvSpPr txBox="1"/>
          <p:nvPr/>
        </p:nvSpPr>
        <p:spPr>
          <a:xfrm>
            <a:off x="444872" y="8533644"/>
            <a:ext cx="5961873" cy="4462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ja-JP" sz="105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pplementary Video 1.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3D images of PPs at 2, 4, and 10 weeks of age obtained using Amira. Representative image of 2- (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A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, 4- (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, and 10- (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 weeks.</a:t>
            </a:r>
            <a:endParaRPr lang="ja-JP" altLang="ja-JP" sz="105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endParaRPr kumimoji="1" lang="ja-JP" altLang="en-US" sz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0947289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7"/>
                </p:tgtEl>
              </p:cMediaNode>
            </p:video>
            <p:video>
              <p:cMediaNode vol="80000">
                <p:cTn id="4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56</Words>
  <Application>Microsoft Office PowerPoint</Application>
  <PresentationFormat>A4 210 x 297 mm</PresentationFormat>
  <Paragraphs>9</Paragraphs>
  <Slides>1</Slides>
  <Notes>0</Notes>
  <HiddenSlides>0</HiddenSlides>
  <MMClips>3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智法 野地</dc:creator>
  <cp:lastModifiedBy>野地　智法</cp:lastModifiedBy>
  <cp:revision>4</cp:revision>
  <dcterms:created xsi:type="dcterms:W3CDTF">2024-01-17T08:54:18Z</dcterms:created>
  <dcterms:modified xsi:type="dcterms:W3CDTF">2024-06-12T08:33:49Z</dcterms:modified>
</cp:coreProperties>
</file>